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304" r:id="rId2"/>
  </p:sldIdLst>
  <p:sldSz cx="12192000" cy="6858000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FF"/>
    <a:srgbClr val="FF99CC"/>
    <a:srgbClr val="9CF8A0"/>
    <a:srgbClr val="FFFFCC"/>
    <a:srgbClr val="2BF343"/>
    <a:srgbClr val="E7FF01"/>
    <a:srgbClr val="99FFCC"/>
    <a:srgbClr val="00FF00"/>
    <a:srgbClr val="FFFF00"/>
    <a:srgbClr val="00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09" autoAdjust="0"/>
    <p:restoredTop sz="89196" autoAdjust="0"/>
  </p:normalViewPr>
  <p:slideViewPr>
    <p:cSldViewPr snapToGrid="0">
      <p:cViewPr varScale="1">
        <p:scale>
          <a:sx n="100" d="100"/>
          <a:sy n="100" d="100"/>
        </p:scale>
        <p:origin x="924" y="72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14410609440263"/>
          <c:y val="2.2138330048526281E-2"/>
          <c:w val="0.93030566246483759"/>
          <c:h val="0.793590710252127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ata Sup Table 2'!$A$6</c:f>
              <c:strCache>
                <c:ptCount val="1"/>
                <c:pt idx="0">
                  <c:v>Total Env (Env only + shared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Data Sup Table 2'!$B$3:$I$3</c:f>
              <c:strCache>
                <c:ptCount val="8"/>
                <c:pt idx="0">
                  <c:v>Plastid</c:v>
                </c:pt>
                <c:pt idx="1">
                  <c:v>Cytosol</c:v>
                </c:pt>
                <c:pt idx="2">
                  <c:v>ExtraC/ER/Golgi</c:v>
                </c:pt>
                <c:pt idx="3">
                  <c:v>Mitochondria</c:v>
                </c:pt>
                <c:pt idx="4">
                  <c:v>Nucleus</c:v>
                </c:pt>
                <c:pt idx="5">
                  <c:v>Plasma membrane</c:v>
                </c:pt>
                <c:pt idx="6">
                  <c:v>Peroxisome</c:v>
                </c:pt>
                <c:pt idx="7">
                  <c:v>Vacuole</c:v>
                </c:pt>
              </c:strCache>
            </c:strRef>
          </c:cat>
          <c:val>
            <c:numRef>
              <c:f>'Data Sup Table 2'!$B$6:$I$6</c:f>
              <c:numCache>
                <c:formatCode>General</c:formatCode>
                <c:ptCount val="8"/>
                <c:pt idx="0">
                  <c:v>787</c:v>
                </c:pt>
                <c:pt idx="1">
                  <c:v>157</c:v>
                </c:pt>
                <c:pt idx="2">
                  <c:v>106</c:v>
                </c:pt>
                <c:pt idx="3">
                  <c:v>58</c:v>
                </c:pt>
                <c:pt idx="4">
                  <c:v>18</c:v>
                </c:pt>
                <c:pt idx="5">
                  <c:v>56</c:v>
                </c:pt>
                <c:pt idx="6">
                  <c:v>33</c:v>
                </c:pt>
                <c:pt idx="7">
                  <c:v>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FFC-47FB-AA93-7AF1EB53EE29}"/>
            </c:ext>
          </c:extLst>
        </c:ser>
        <c:ser>
          <c:idx val="1"/>
          <c:order val="1"/>
          <c:tx>
            <c:strRef>
              <c:f>'Data Sup Table 2'!$A$9</c:f>
              <c:strCache>
                <c:ptCount val="1"/>
                <c:pt idx="0">
                  <c:v>Tota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Data Sup Table 2'!$B$3:$I$3</c:f>
              <c:strCache>
                <c:ptCount val="8"/>
                <c:pt idx="0">
                  <c:v>Plastid</c:v>
                </c:pt>
                <c:pt idx="1">
                  <c:v>Cytosol</c:v>
                </c:pt>
                <c:pt idx="2">
                  <c:v>ExtraC/ER/Golgi</c:v>
                </c:pt>
                <c:pt idx="3">
                  <c:v>Mitochondria</c:v>
                </c:pt>
                <c:pt idx="4">
                  <c:v>Nucleus</c:v>
                </c:pt>
                <c:pt idx="5">
                  <c:v>Plasma membrane</c:v>
                </c:pt>
                <c:pt idx="6">
                  <c:v>Peroxisome</c:v>
                </c:pt>
                <c:pt idx="7">
                  <c:v>Vacuole</c:v>
                </c:pt>
              </c:strCache>
            </c:strRef>
          </c:cat>
          <c:val>
            <c:numRef>
              <c:f>'Data Sup Table 2'!$B$9:$I$9</c:f>
              <c:numCache>
                <c:formatCode>General</c:formatCode>
                <c:ptCount val="8"/>
                <c:pt idx="0">
                  <c:v>1017</c:v>
                </c:pt>
                <c:pt idx="1">
                  <c:v>593</c:v>
                </c:pt>
                <c:pt idx="2">
                  <c:v>292</c:v>
                </c:pt>
                <c:pt idx="3">
                  <c:v>204</c:v>
                </c:pt>
                <c:pt idx="4">
                  <c:v>104</c:v>
                </c:pt>
                <c:pt idx="5">
                  <c:v>117</c:v>
                </c:pt>
                <c:pt idx="6">
                  <c:v>75</c:v>
                </c:pt>
                <c:pt idx="7">
                  <c:v>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FFC-47FB-AA93-7AF1EB53EE29}"/>
            </c:ext>
          </c:extLst>
        </c:ser>
        <c:ser>
          <c:idx val="2"/>
          <c:order val="2"/>
          <c:tx>
            <c:strRef>
              <c:f>'Data Sup Table 2'!$A$8</c:f>
              <c:strCache>
                <c:ptCount val="1"/>
                <c:pt idx="0">
                  <c:v>Total CCE (CCE only + shared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Data Sup Table 2'!$B$3:$I$3</c:f>
              <c:strCache>
                <c:ptCount val="8"/>
                <c:pt idx="0">
                  <c:v>Plastid</c:v>
                </c:pt>
                <c:pt idx="1">
                  <c:v>Cytosol</c:v>
                </c:pt>
                <c:pt idx="2">
                  <c:v>ExtraC/ER/Golgi</c:v>
                </c:pt>
                <c:pt idx="3">
                  <c:v>Mitochondria</c:v>
                </c:pt>
                <c:pt idx="4">
                  <c:v>Nucleus</c:v>
                </c:pt>
                <c:pt idx="5">
                  <c:v>Plasma membrane</c:v>
                </c:pt>
                <c:pt idx="6">
                  <c:v>Peroxisome</c:v>
                </c:pt>
                <c:pt idx="7">
                  <c:v>Vacuole</c:v>
                </c:pt>
              </c:strCache>
            </c:strRef>
          </c:cat>
          <c:val>
            <c:numRef>
              <c:f>'Data Sup Table 2'!$B$8:$I$8</c:f>
              <c:numCache>
                <c:formatCode>General</c:formatCode>
                <c:ptCount val="8"/>
                <c:pt idx="0">
                  <c:v>848</c:v>
                </c:pt>
                <c:pt idx="1">
                  <c:v>571</c:v>
                </c:pt>
                <c:pt idx="2">
                  <c:v>277</c:v>
                </c:pt>
                <c:pt idx="3">
                  <c:v>187</c:v>
                </c:pt>
                <c:pt idx="4">
                  <c:v>97</c:v>
                </c:pt>
                <c:pt idx="5">
                  <c:v>109</c:v>
                </c:pt>
                <c:pt idx="6">
                  <c:v>69</c:v>
                </c:pt>
                <c:pt idx="7">
                  <c:v>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FFC-47FB-AA93-7AF1EB53EE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274696"/>
        <c:axId val="194609616"/>
      </c:barChart>
      <c:catAx>
        <c:axId val="9274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94609616"/>
        <c:crosses val="autoZero"/>
        <c:auto val="1"/>
        <c:lblAlgn val="ctr"/>
        <c:lblOffset val="100"/>
        <c:noMultiLvlLbl val="0"/>
      </c:catAx>
      <c:valAx>
        <c:axId val="1946096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274696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b"/>
      <c:layout>
        <c:manualLayout>
          <c:xMode val="edge"/>
          <c:yMode val="edge"/>
          <c:x val="0.32252794582124578"/>
          <c:y val="9.9125735477722021E-2"/>
          <c:w val="0.61541309461338367"/>
          <c:h val="0.1852291630764685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390" tIns="47695" rIns="95390" bIns="47695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390" tIns="47695" rIns="95390" bIns="47695" rtlCol="0"/>
          <a:lstStyle>
            <a:lvl1pPr algn="r">
              <a:defRPr sz="1300"/>
            </a:lvl1pPr>
          </a:lstStyle>
          <a:p>
            <a:fld id="{4110BF96-1A77-4303-8468-6D4F197C9A1B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479425" y="1277938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390" tIns="47695" rIns="95390" bIns="47695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709931" y="4925408"/>
            <a:ext cx="5679440" cy="4029879"/>
          </a:xfrm>
          <a:prstGeom prst="rect">
            <a:avLst/>
          </a:prstGeom>
        </p:spPr>
        <p:txBody>
          <a:bodyPr vert="horz" lIns="95390" tIns="47695" rIns="95390" bIns="47695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5390" tIns="47695" rIns="95390" bIns="47695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5390" tIns="47695" rIns="95390" bIns="47695" rtlCol="0" anchor="b"/>
          <a:lstStyle>
            <a:lvl1pPr algn="r">
              <a:defRPr sz="1300"/>
            </a:lvl1pPr>
          </a:lstStyle>
          <a:p>
            <a:fld id="{76A9539B-17B8-4317-A85C-D10932E739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2771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334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84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187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810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20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806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439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79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997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003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492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AF230-4ACB-47E6-B153-50E1F8E5A04D}" type="datetimeFigureOut">
              <a:rPr lang="en-US" smtClean="0"/>
              <a:t>9/7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918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-30107" y="4786293"/>
            <a:ext cx="12222107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4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subcellular localization of proteins identified in purified envelope fractions and crude cell extracts according to the SUBA3 databas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Ac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ee Hooper et al., 2014)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s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per part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%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er part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identified in various cell compartments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ote that only 10% (257) of the 2479 detected proteins were only detected in purified envelope fractions (not in the crude cell extract). Not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7%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87) of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17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ti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identifi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purified envelop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action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versely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E contai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e proteins predicted to be localized in other cell compartments. Surprisingly, purified envelope fraction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ain 53 (69%) of the 77 detected proteins that are predicted to be vacuolar components. </a:t>
            </a:r>
          </a:p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phical representation of data from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Note that only vacuolar proteins are almost as abundant in purified envelope fractions when compared to CCE.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Not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2% (787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1268 protei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urified envelop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ctions are predicted to be plastid proteins (onl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8%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detected in CC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Conversely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ains more proteins predicted to be localized in other cell compartment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ain, not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t predicted vacuolar protein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enriched in purifi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velop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actio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%) wh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ed to their relative abundance in CCE (3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). </a:t>
            </a:r>
            <a:endParaRPr 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leau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3685564"/>
              </p:ext>
            </p:extLst>
          </p:nvPr>
        </p:nvGraphicFramePr>
        <p:xfrm>
          <a:off x="577047" y="609600"/>
          <a:ext cx="8406932" cy="3534569"/>
        </p:xfrm>
        <a:graphic>
          <a:graphicData uri="http://schemas.openxmlformats.org/drawingml/2006/table">
            <a:tbl>
              <a:tblPr/>
              <a:tblGrid>
                <a:gridCol w="200990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6115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64646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2295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5821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8172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46461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65821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728738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87693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0541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</a:tblGrid>
              <a:tr h="486569"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tid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os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traC/ER/Golg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to-</a:t>
                      </a:r>
                      <a:r>
                        <a:rPr lang="fr-FR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ndria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cle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 membra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roxisom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cuol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v + CCE (shar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,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v-only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0,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v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v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only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 shar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,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E-</a:t>
                      </a:r>
                      <a:r>
                        <a:rPr lang="fr-FR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ly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,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CCE (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E-only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 shar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F8A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,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,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in Env + CCE (shar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in </a:t>
                      </a:r>
                      <a:r>
                        <a:rPr lang="fr-FR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v-only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in Total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v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v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only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 shar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in </a:t>
                      </a:r>
                      <a:r>
                        <a:rPr lang="fr-F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E-</a:t>
                      </a:r>
                      <a:r>
                        <a:rPr lang="fr-FR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ly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in Total CCE (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E-only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 shar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F8A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of </a:t>
                      </a:r>
                      <a:r>
                        <a:rPr lang="fr-FR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v-only</a:t>
                      </a:r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ared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,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,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of </a:t>
                      </a:r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E-</a:t>
                      </a:r>
                      <a:r>
                        <a:rPr lang="fr-FR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nly</a:t>
                      </a:r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ared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,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,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F8A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,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of all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s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,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,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,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</a:tbl>
          </a:graphicData>
        </a:graphic>
      </p:graphicFrame>
      <p:sp>
        <p:nvSpPr>
          <p:cNvPr id="9" name="ZoneTexte 8"/>
          <p:cNvSpPr txBox="1"/>
          <p:nvPr/>
        </p:nvSpPr>
        <p:spPr>
          <a:xfrm>
            <a:off x="24045" y="147657"/>
            <a:ext cx="49564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4000" b="1" dirty="0" smtClean="0"/>
              <a:t>A</a:t>
            </a:r>
            <a:endParaRPr lang="fr-FR" sz="4000" b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24045" y="3209408"/>
            <a:ext cx="47160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4000" b="1" dirty="0" smtClean="0"/>
              <a:t>C</a:t>
            </a:r>
            <a:endParaRPr lang="fr-FR" sz="4000" b="1" dirty="0"/>
          </a:p>
        </p:txBody>
      </p:sp>
      <p:graphicFrame>
        <p:nvGraphicFramePr>
          <p:cNvPr id="12" name="Graphique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7475303"/>
              </p:ext>
            </p:extLst>
          </p:nvPr>
        </p:nvGraphicFramePr>
        <p:xfrm>
          <a:off x="9156542" y="147657"/>
          <a:ext cx="2827972" cy="45494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ZoneTexte 12"/>
          <p:cNvSpPr txBox="1"/>
          <p:nvPr/>
        </p:nvSpPr>
        <p:spPr>
          <a:xfrm>
            <a:off x="8512375" y="147657"/>
            <a:ext cx="47160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4000" b="1" dirty="0" smtClean="0"/>
              <a:t>B</a:t>
            </a:r>
            <a:endParaRPr lang="fr-FR" sz="4000" b="1" dirty="0"/>
          </a:p>
        </p:txBody>
      </p:sp>
    </p:spTree>
    <p:extLst>
      <p:ext uri="{BB962C8B-B14F-4D97-AF65-F5344CB8AC3E}">
        <p14:creationId xmlns:p14="http://schemas.microsoft.com/office/powerpoint/2010/main" val="5940620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62</TotalTime>
  <Words>454</Words>
  <Application>Microsoft Office PowerPoint</Application>
  <PresentationFormat>Grand écran</PresentationFormat>
  <Paragraphs>15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E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OUCHNAK Imen 247267</dc:creator>
  <cp:lastModifiedBy>ROLLAND Norbert 154855</cp:lastModifiedBy>
  <cp:revision>743</cp:revision>
  <cp:lastPrinted>2018-02-27T18:17:38Z</cp:lastPrinted>
  <dcterms:created xsi:type="dcterms:W3CDTF">2017-06-14T16:26:33Z</dcterms:created>
  <dcterms:modified xsi:type="dcterms:W3CDTF">2018-09-07T06:17:19Z</dcterms:modified>
</cp:coreProperties>
</file>